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?橋　達也" initials="?" lastIdx="7" clrIdx="0">
    <p:extLst>
      <p:ext uri="{19B8F6BF-5375-455C-9EA6-DF929625EA0E}">
        <p15:presenceInfo xmlns:p15="http://schemas.microsoft.com/office/powerpoint/2012/main" userId="?橋　達也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0000"/>
    <a:srgbClr val="E6E6E6"/>
    <a:srgbClr val="000000"/>
    <a:srgbClr val="DADADA"/>
    <a:srgbClr val="7F7F7F"/>
    <a:srgbClr val="FFFFFF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11" autoAdjust="0"/>
    <p:restoredTop sz="94660"/>
  </p:normalViewPr>
  <p:slideViewPr>
    <p:cSldViewPr snapToGrid="0">
      <p:cViewPr varScale="1">
        <p:scale>
          <a:sx n="86" d="100"/>
          <a:sy n="86" d="100"/>
        </p:scale>
        <p:origin x="59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00C4AA-37B0-4DB4-A3A5-136696E77C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A50B4D7-ED9E-4D3B-A1D6-D491260672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289610-8EC1-463E-A0C5-B9493F874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59A866B-B46B-42FC-B34F-2CBA0DB73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CFB0DE-9AF3-4F6B-9EC7-A3FC3183B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072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06FD66-573D-44DB-B20C-821106FB0E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A6DEDD9-894A-4E5A-8ADB-4F0197EDF5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4F3EA4-C721-4365-9D4A-4E1FE5421B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905043-9350-40B1-B65A-C62A237EE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72B902-7A34-4E6D-9AC0-EC0DF204C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5942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BDAB14B-15FC-442B-A915-DD6F584316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A6FB19F-376A-4B93-B7C6-9CB5A7D662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B67475-C76D-4E99-AF44-94AC25E74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424A41-02BA-4B33-8B6A-892E31E0E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907791-6F23-4D88-B237-46176F44F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0326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02F55A-922C-468A-920B-7591E852E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CD5A50C-5C7C-422D-92FF-E3DEE0C887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B1B921-0C13-4DB9-9771-F7273AA921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789266-1F54-436A-95EF-39068A150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33BB766-696B-4EEA-B638-B8113BE7D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763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EDB8DA-5FEA-448A-AA69-9A5BE8F8D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A6601B-0C15-4318-8B8A-DA30DE9B7F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F0E232-1CEF-4370-94E8-4BCD1ECF3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FA3BE3-38A2-4912-A095-34EEF95C1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6E78CA-61ED-4C52-BD87-37EF56196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3055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DE9963-C40A-4F9C-B013-9325339445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DAF640-5F9B-4F3C-8B8D-7E837E3EE3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E331B3B-73FF-48F5-B841-5C98F2F030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6F3A78-C98F-420A-9627-D4BEE51A0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D960893-8DCE-45F7-8FFC-6568FC1F5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98BA551-CEDE-409A-8B6A-8B967BF36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1249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9FB044-692B-4CB9-AB1F-8929ABAE2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17E885F-C9D0-401A-9A70-904D16D275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29AAB9A-14E2-4A63-B9E3-EA39A49BA4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532C791-7178-40A5-BC79-3FBA3B44B4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D941943-27AE-42A3-B613-54F2B40CD3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436928E-91CC-4B3D-A0CA-9A8FDB9A0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6C35603-24DF-443B-B6BC-B4E527090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410C085-5914-4D43-A835-66B52041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0979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5FA50D-C27A-4774-840E-AAE4F03D8D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7AE20F3-93A5-4133-AB57-8ED15E1B3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2F1C6B2-3637-4156-A3CE-58F0D06C3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A342AA6-F6FF-40B7-A44B-B805E537F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064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6ECE84C-F234-4BD3-9E43-15EE2AF9E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BFE425D-4184-432C-AB88-5D47290B3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24FB409-4FFC-40B6-AFA8-C4B5FDBD0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077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EC1E84-12B6-43EA-8F12-35E0B6EE8C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C129F48-79E7-4ACE-B7B1-992F228336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FA58628-7D6D-4273-A235-21B5E018CA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70672AB-78A9-4459-9ECB-0A19DEE27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ACBA9C1-F50A-4F4D-ACF3-9BD282331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2539AA1-E662-4BEA-B570-98C086553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541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207123-6FA3-44AF-B3C3-45C42738BD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51F592E-51ED-4A5B-BD73-B4C7500F6C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197B1B1-ACB3-43A7-BEBB-A6049E58C2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D0107F4-6D8E-4DCA-915D-F6A301C8E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9520C26-45E3-404D-9601-809D1B43F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3D84551-CABC-469D-988A-A9EA15920B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1958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B51A9A2-7C11-4372-BE5C-0D1E4E473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57532D-E3CC-4644-BFA2-6D2C146F1E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B4BA8B-064B-44C1-BC22-3A38772E5E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F9881-E197-4B53-8427-60DD3927F218}" type="datetimeFigureOut">
              <a:rPr kumimoji="1" lang="ja-JP" altLang="en-US" smtClean="0"/>
              <a:t>2021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2AB6EB-B6F4-4E59-BA7A-1FC689B825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B59D23-CC00-4A0B-BB81-6E1B6199D0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7DE54D-42ED-42D8-AD88-977B71E57B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9081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nms-tropy@eng.hokudai.ac.jp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D4A6D63D-A85B-413F-984A-3A0F395BB671}"/>
              </a:ext>
            </a:extLst>
          </p:cNvPr>
          <p:cNvSpPr/>
          <p:nvPr/>
        </p:nvSpPr>
        <p:spPr>
          <a:xfrm>
            <a:off x="1052199" y="184836"/>
            <a:ext cx="10310270" cy="61555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</a:t>
            </a:r>
            <a:r>
              <a:rPr lang="ja-JP" altLang="en-US" b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b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formation</a:t>
            </a:r>
          </a:p>
          <a:p>
            <a:endParaRPr lang="en-US" altLang="ja-JP" b="1" kern="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</a:pPr>
            <a:r>
              <a:rPr lang="en-US" altLang="ja-JP" sz="2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atalyst-loaded micro-encapsulated phase change material 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</a:pPr>
            <a:r>
              <a:rPr lang="en-US" altLang="ja-JP" sz="2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or thermal control of exothermic reaction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sz="2800" b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atsuya Takahashi</a:t>
            </a:r>
            <a:r>
              <a:rPr lang="en-US" altLang="ja-JP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Hiroaki Koide</a:t>
            </a:r>
            <a:r>
              <a:rPr lang="en-US" altLang="ja-JP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akai Hiroki</a:t>
            </a:r>
            <a:r>
              <a:rPr lang="en-US" altLang="ja-JP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kern="0" baseline="-25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</a:t>
            </a:r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aisuke Ajito</a:t>
            </a:r>
            <a:r>
              <a:rPr lang="en-US" altLang="ja-JP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de Kurniawan</a:t>
            </a:r>
            <a:r>
              <a:rPr lang="en-US" altLang="ja-JP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nd Yuji Kunisada</a:t>
            </a:r>
            <a:r>
              <a:rPr lang="en-US" altLang="ja-JP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akahiro Nomura</a:t>
            </a:r>
            <a:r>
              <a:rPr lang="en-US" altLang="ja-JP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i="1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aduate School of Engineering, Hokkaido University, Kita 13 Nishi 8, Kita-</a:t>
            </a:r>
            <a:r>
              <a:rPr lang="en-US" altLang="ja-JP" i="1" kern="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u</a:t>
            </a:r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apporo, 060-8628 Japan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i="1" kern="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aculty of Engineering, Hokkaido University, Kita 13 Nishi 8, Kita-</a:t>
            </a:r>
            <a:r>
              <a:rPr lang="en-US" altLang="ja-JP" i="1" kern="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u</a:t>
            </a:r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apporo, 060-8628 Japan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.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el.: +81 11 706 6842; fax: +81 11 706 6849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-mail address: </a:t>
            </a:r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nms-tropy@eng.hokudai.ac.jp</a:t>
            </a:r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i="1" kern="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.Nomura</a:t>
            </a:r>
            <a:r>
              <a:rPr lang="en-US" altLang="ja-JP" i="1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4348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図 83">
            <a:extLst>
              <a:ext uri="{FF2B5EF4-FFF2-40B4-BE49-F238E27FC236}">
                <a16:creationId xmlns:a16="http://schemas.microsoft.com/office/drawing/2014/main" id="{ECD3CE68-6F5C-43E5-BD4A-5CDAB492DE8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05" t="6348" r="5787" b="7325"/>
          <a:stretch/>
        </p:blipFill>
        <p:spPr>
          <a:xfrm>
            <a:off x="6245003" y="616380"/>
            <a:ext cx="4150523" cy="3265599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4" name="テキスト ボックス 3">
                <a:extLst>
                  <a:ext uri="{FF2B5EF4-FFF2-40B4-BE49-F238E27FC236}">
                    <a16:creationId xmlns:a16="http://schemas.microsoft.com/office/drawing/2014/main" id="{3FAD60FF-F001-4450-A474-A1CCB09FE644}"/>
                  </a:ext>
                </a:extLst>
              </p:cNvPr>
              <p:cNvSpPr txBox="1"/>
              <p:nvPr/>
            </p:nvSpPr>
            <p:spPr>
              <a:xfrm>
                <a:off x="399910" y="4769514"/>
                <a:ext cx="10149472" cy="19422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. S1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he concentration of CH</a:t>
                </a:r>
                <a:r>
                  <a:rPr lang="en-US" altLang="ja-JP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CO in the outlet gas over Ni/MEPCM during CO</a:t>
                </a:r>
                <a:r>
                  <a:rPr lang="en-US" altLang="ja-JP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ethanation. Feed gas was introduced at 1 min after the starts of measurement.</a:t>
                </a:r>
              </a:p>
              <a:p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 the condition (</a:t>
                </a:r>
                <a:r>
                  <a:rPr lang="en-US" altLang="ja-JP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, the</a:t>
                </a:r>
                <a:r>
                  <a:rPr lang="ja-JP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PCM has heat storage capacity. In the condition (ii), the MEPCM does not have it. Reaction condition: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</m:ctrlPr>
                      </m:sSubPr>
                      <m:e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𝐹</m:t>
                        </m:r>
                      </m:e>
                      <m:sub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𝑖𝑛</m:t>
                        </m:r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, </m:t>
                        </m:r>
                        <m:sSub>
                          <m:sSubPr>
                            <m:ctrlPr>
                              <a:rPr lang="en-US" altLang="ja-JP" i="1"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</m:ctrlPr>
                          </m:sSubPr>
                          <m:e>
                            <m:r>
                              <a:rPr lang="en-US" altLang="ja-JP" i="1"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  <m:t>𝐶𝑂</m:t>
                            </m:r>
                          </m:e>
                          <m:sub>
                            <m:r>
                              <a:rPr lang="en-US" altLang="ja-JP" i="1"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  <m:t>2</m:t>
                            </m:r>
                          </m:sub>
                        </m:sSub>
                      </m:sub>
                    </m:sSub>
                  </m:oMath>
                </a14:m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 15 ml min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</a:t>
                </a:r>
                <a:r>
                  <a:rPr lang="en-US" altLang="ja-JP" dirty="0">
                    <a:cs typeface="Times New Roman" panose="02020603050405020304" pitchFamily="18" charset="0"/>
                  </a:rPr>
                  <a:t>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</m:ctrlPr>
                      </m:sSubPr>
                      <m:e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𝐹</m:t>
                        </m:r>
                      </m:e>
                      <m:sub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𝑖𝑛</m:t>
                        </m:r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, </m:t>
                        </m:r>
                        <m:sSub>
                          <m:sSubPr>
                            <m:ctrlPr>
                              <a:rPr lang="en-US" altLang="ja-JP" i="1"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</m:ctrlPr>
                          </m:sSubPr>
                          <m:e>
                            <m:r>
                              <a:rPr lang="en-US" altLang="ja-JP" i="1"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  <m:t>𝐻</m:t>
                            </m:r>
                          </m:e>
                          <m:sub>
                            <m:r>
                              <a:rPr lang="en-US" altLang="ja-JP" i="1"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  <m:t>2</m:t>
                            </m:r>
                          </m:sub>
                        </m:sSub>
                      </m:sub>
                    </m:sSub>
                  </m:oMath>
                </a14:m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 60 ml min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</a:t>
                </a:r>
                <a:r>
                  <a:rPr lang="en-US" altLang="ja-JP" dirty="0">
                    <a:cs typeface="Times New Roman" panose="02020603050405020304" pitchFamily="18" charset="0"/>
                  </a:rPr>
                  <a:t>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</m:ctrlPr>
                      </m:sSubPr>
                      <m:e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𝐹</m:t>
                        </m:r>
                      </m:e>
                      <m:sub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𝑖𝑛</m:t>
                        </m:r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, </m:t>
                        </m:r>
                        <m:r>
                          <a:rPr lang="en-US" altLang="ja-JP" i="1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𝐴𝑟</m:t>
                        </m:r>
                      </m:sub>
                    </m:sSub>
                  </m:oMath>
                </a14:m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 50 ml min</a:t>
                </a:r>
                <a:r>
                  <a:rPr lang="en-US" altLang="ja-JP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Reaction temperature: 560ºC. Each curve represents the average concentration of five measurements, and  error bars indicate SD </a:t>
                </a:r>
                <a:r>
                  <a:rPr lang="en-US" altLang="ja-JP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 concentration </a:t>
                </a: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 each time.</a:t>
                </a:r>
              </a:p>
              <a:p>
                <a:endParaRPr lang="en-US" altLang="ja-JP" sz="16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4" name="テキスト ボックス 3">
                <a:extLst>
                  <a:ext uri="{FF2B5EF4-FFF2-40B4-BE49-F238E27FC236}">
                    <a16:creationId xmlns:a16="http://schemas.microsoft.com/office/drawing/2014/main" id="{3FAD60FF-F001-4450-A474-A1CCB09FE64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99910" y="4769514"/>
                <a:ext cx="10149472" cy="1942263"/>
              </a:xfrm>
              <a:prstGeom prst="rect">
                <a:avLst/>
              </a:prstGeom>
              <a:blipFill>
                <a:blip r:embed="rId3"/>
                <a:stretch>
                  <a:fillRect l="-541" t="-1567" r="-781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725F1AB-80E8-498E-BA32-6FF5E931DC6C}"/>
              </a:ext>
            </a:extLst>
          </p:cNvPr>
          <p:cNvSpPr txBox="1"/>
          <p:nvPr/>
        </p:nvSpPr>
        <p:spPr>
          <a:xfrm rot="16200000">
            <a:off x="-161135" y="1961176"/>
            <a:ext cx="2039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+mj-lt"/>
                <a:ea typeface="+mj-ea"/>
                <a:cs typeface="Arial" panose="020B0604020202020204" pitchFamily="34" charset="0"/>
              </a:rPr>
              <a:t>Concentration </a:t>
            </a:r>
            <a:r>
              <a:rPr kumimoji="1" lang="en-US" altLang="ja-JP" dirty="0">
                <a:cs typeface="Arial" panose="020B0604020202020204" pitchFamily="34" charset="0"/>
              </a:rPr>
              <a:t>[%]</a:t>
            </a:r>
            <a:endParaRPr kumimoji="1" lang="ja-JP" altLang="en-US" dirty="0">
              <a:latin typeface="+mj-lt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74AE70B-FED9-40EE-ACE5-7E6CBEF47502}"/>
              </a:ext>
            </a:extLst>
          </p:cNvPr>
          <p:cNvSpPr txBox="1"/>
          <p:nvPr/>
        </p:nvSpPr>
        <p:spPr>
          <a:xfrm>
            <a:off x="1190980" y="3814787"/>
            <a:ext cx="333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0</a:t>
            </a:r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53D2854-CA3E-4987-86B5-BD4F99DCA2A4}"/>
              </a:ext>
            </a:extLst>
          </p:cNvPr>
          <p:cNvSpPr txBox="1"/>
          <p:nvPr/>
        </p:nvSpPr>
        <p:spPr>
          <a:xfrm>
            <a:off x="1723045" y="3814787"/>
            <a:ext cx="329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B72F7FB-582A-40F0-AE42-AB136B9ED6CB}"/>
              </a:ext>
            </a:extLst>
          </p:cNvPr>
          <p:cNvSpPr txBox="1"/>
          <p:nvPr/>
        </p:nvSpPr>
        <p:spPr>
          <a:xfrm>
            <a:off x="3186895" y="3814787"/>
            <a:ext cx="32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4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7D34A6D-76EA-47D6-AE10-A3045AB36609}"/>
              </a:ext>
            </a:extLst>
          </p:cNvPr>
          <p:cNvSpPr txBox="1"/>
          <p:nvPr/>
        </p:nvSpPr>
        <p:spPr>
          <a:xfrm>
            <a:off x="2696844" y="3814787"/>
            <a:ext cx="3715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3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3F5FDA6-6080-46BB-89BB-3FE6295FA41F}"/>
              </a:ext>
            </a:extLst>
          </p:cNvPr>
          <p:cNvSpPr txBox="1"/>
          <p:nvPr/>
        </p:nvSpPr>
        <p:spPr>
          <a:xfrm>
            <a:off x="2199146" y="3814787"/>
            <a:ext cx="329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2</a:t>
            </a:r>
            <a:endParaRPr kumimoji="1"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6CB4969-DBF1-4E5D-AABE-58DE5208497D}"/>
              </a:ext>
            </a:extLst>
          </p:cNvPr>
          <p:cNvSpPr txBox="1"/>
          <p:nvPr/>
        </p:nvSpPr>
        <p:spPr>
          <a:xfrm>
            <a:off x="3698642" y="3814787"/>
            <a:ext cx="320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5</a:t>
            </a:r>
            <a:endParaRPr kumimoji="1"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F712D11-7792-47BE-9518-DAA4D2B7BE51}"/>
              </a:ext>
            </a:extLst>
          </p:cNvPr>
          <p:cNvSpPr txBox="1"/>
          <p:nvPr/>
        </p:nvSpPr>
        <p:spPr>
          <a:xfrm>
            <a:off x="5215279" y="3814787"/>
            <a:ext cx="528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8</a:t>
            </a:r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977E857-3442-4E02-8CDF-10B7DA1AF0E2}"/>
              </a:ext>
            </a:extLst>
          </p:cNvPr>
          <p:cNvSpPr txBox="1"/>
          <p:nvPr/>
        </p:nvSpPr>
        <p:spPr>
          <a:xfrm>
            <a:off x="1047491" y="2397067"/>
            <a:ext cx="262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4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27FDCC4-B3EB-41CD-B820-761DA23D5A04}"/>
              </a:ext>
            </a:extLst>
          </p:cNvPr>
          <p:cNvSpPr txBox="1"/>
          <p:nvPr/>
        </p:nvSpPr>
        <p:spPr>
          <a:xfrm>
            <a:off x="1047491" y="3002526"/>
            <a:ext cx="333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2</a:t>
            </a:r>
            <a:endParaRPr kumimoji="1" lang="ja-JP" altLang="en-US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43B62BE-55DF-42B6-9C79-C30E94B57CE9}"/>
              </a:ext>
            </a:extLst>
          </p:cNvPr>
          <p:cNvSpPr txBox="1"/>
          <p:nvPr/>
        </p:nvSpPr>
        <p:spPr>
          <a:xfrm>
            <a:off x="1055443" y="1776510"/>
            <a:ext cx="275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6</a:t>
            </a:r>
            <a:endParaRPr kumimoji="1"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B4CC625-2C20-489E-8209-4F83AAF94DAF}"/>
              </a:ext>
            </a:extLst>
          </p:cNvPr>
          <p:cNvSpPr txBox="1"/>
          <p:nvPr/>
        </p:nvSpPr>
        <p:spPr>
          <a:xfrm>
            <a:off x="1055443" y="1151377"/>
            <a:ext cx="280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8</a:t>
            </a:r>
            <a:endParaRPr kumimoji="1" lang="ja-JP" altLang="en-US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CC0F467-2BAA-4027-92C8-2B528F145E41}"/>
              </a:ext>
            </a:extLst>
          </p:cNvPr>
          <p:cNvSpPr txBox="1"/>
          <p:nvPr/>
        </p:nvSpPr>
        <p:spPr>
          <a:xfrm>
            <a:off x="977499" y="521330"/>
            <a:ext cx="459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0</a:t>
            </a:r>
            <a:endParaRPr kumimoji="1" lang="ja-JP" altLang="en-US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7A98547-DE9D-4A6F-89A4-21665D36DD0E}"/>
              </a:ext>
            </a:extLst>
          </p:cNvPr>
          <p:cNvSpPr txBox="1"/>
          <p:nvPr/>
        </p:nvSpPr>
        <p:spPr>
          <a:xfrm>
            <a:off x="1059953" y="3687398"/>
            <a:ext cx="333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0</a:t>
            </a:r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28484A3-6A7F-4AE1-9BD3-0D8B00EE687B}"/>
              </a:ext>
            </a:extLst>
          </p:cNvPr>
          <p:cNvSpPr txBox="1"/>
          <p:nvPr/>
        </p:nvSpPr>
        <p:spPr>
          <a:xfrm>
            <a:off x="2725163" y="4109829"/>
            <a:ext cx="141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cs typeface="Arial" panose="020B0604020202020204" pitchFamily="34" charset="0"/>
              </a:rPr>
              <a:t>Time [</a:t>
            </a:r>
            <a:r>
              <a:rPr lang="en-US" altLang="ja-JP" dirty="0">
                <a:cs typeface="Arial" panose="020B0604020202020204" pitchFamily="34" charset="0"/>
              </a:rPr>
              <a:t>min</a:t>
            </a:r>
            <a:r>
              <a:rPr kumimoji="1" lang="en-US" altLang="ja-JP" dirty="0">
                <a:cs typeface="Arial" panose="020B0604020202020204" pitchFamily="34" charset="0"/>
              </a:rPr>
              <a:t>]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4B1EDA82-DE5F-4F75-8221-8884AEFAECD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394" t="7008" r="5706" b="6825"/>
          <a:stretch/>
        </p:blipFill>
        <p:spPr>
          <a:xfrm>
            <a:off x="1318233" y="675848"/>
            <a:ext cx="4061422" cy="3196216"/>
          </a:xfrm>
          <a:prstGeom prst="rect">
            <a:avLst/>
          </a:prstGeom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CCA56EF-B2DD-4676-AB9C-54A7C4426B9E}"/>
              </a:ext>
            </a:extLst>
          </p:cNvPr>
          <p:cNvSpPr txBox="1"/>
          <p:nvPr/>
        </p:nvSpPr>
        <p:spPr>
          <a:xfrm>
            <a:off x="4197201" y="3814787"/>
            <a:ext cx="320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6</a:t>
            </a:r>
            <a:endParaRPr kumimoji="1" lang="ja-JP" altLang="en-US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D48EEF3-DAF4-4599-AF49-C62C1D86E64D}"/>
              </a:ext>
            </a:extLst>
          </p:cNvPr>
          <p:cNvSpPr txBox="1"/>
          <p:nvPr/>
        </p:nvSpPr>
        <p:spPr>
          <a:xfrm>
            <a:off x="4685927" y="3814787"/>
            <a:ext cx="320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7</a:t>
            </a:r>
            <a:endParaRPr kumimoji="1" lang="ja-JP" altLang="en-US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7BD7DCA7-2F93-41C4-9EC8-4D0FE5F55CF7}"/>
              </a:ext>
            </a:extLst>
          </p:cNvPr>
          <p:cNvSpPr txBox="1"/>
          <p:nvPr/>
        </p:nvSpPr>
        <p:spPr>
          <a:xfrm rot="16200000">
            <a:off x="4840680" y="1952657"/>
            <a:ext cx="2039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+mj-lt"/>
                <a:ea typeface="+mj-ea"/>
                <a:cs typeface="Arial" panose="020B0604020202020204" pitchFamily="34" charset="0"/>
              </a:rPr>
              <a:t>Concentration </a:t>
            </a:r>
            <a:r>
              <a:rPr kumimoji="1" lang="en-US" altLang="ja-JP" dirty="0">
                <a:cs typeface="Arial" panose="020B0604020202020204" pitchFamily="34" charset="0"/>
              </a:rPr>
              <a:t>[%]</a:t>
            </a:r>
            <a:endParaRPr kumimoji="1" lang="ja-JP" altLang="en-US" dirty="0">
              <a:latin typeface="+mj-lt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BB47D34A-7366-4520-AA0C-06B65A1C62B4}"/>
              </a:ext>
            </a:extLst>
          </p:cNvPr>
          <p:cNvSpPr txBox="1"/>
          <p:nvPr/>
        </p:nvSpPr>
        <p:spPr>
          <a:xfrm>
            <a:off x="6180851" y="3824702"/>
            <a:ext cx="333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0</a:t>
            </a:r>
            <a:endParaRPr kumimoji="1" lang="ja-JP" altLang="en-US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040FC3ED-EBDC-463F-9459-4B043BF4ED9F}"/>
              </a:ext>
            </a:extLst>
          </p:cNvPr>
          <p:cNvSpPr txBox="1"/>
          <p:nvPr/>
        </p:nvSpPr>
        <p:spPr>
          <a:xfrm>
            <a:off x="6712916" y="3824702"/>
            <a:ext cx="329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</a:t>
            </a:r>
            <a:endParaRPr kumimoji="1" lang="ja-JP" altLang="en-US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7E89E31C-3195-4E98-83EC-DB66A7CA1448}"/>
              </a:ext>
            </a:extLst>
          </p:cNvPr>
          <p:cNvSpPr txBox="1"/>
          <p:nvPr/>
        </p:nvSpPr>
        <p:spPr>
          <a:xfrm>
            <a:off x="8184717" y="3824702"/>
            <a:ext cx="32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4</a:t>
            </a:r>
            <a:endParaRPr kumimoji="1" lang="ja-JP" altLang="en-US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5A5CEAAF-6102-4CC7-A950-0BCE28E4536F}"/>
              </a:ext>
            </a:extLst>
          </p:cNvPr>
          <p:cNvSpPr txBox="1"/>
          <p:nvPr/>
        </p:nvSpPr>
        <p:spPr>
          <a:xfrm>
            <a:off x="7686715" y="3824702"/>
            <a:ext cx="3715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3</a:t>
            </a:r>
            <a:endParaRPr kumimoji="1" lang="ja-JP" altLang="en-US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3131DDB-729C-4984-A9FD-74C7280C7DD0}"/>
              </a:ext>
            </a:extLst>
          </p:cNvPr>
          <p:cNvSpPr txBox="1"/>
          <p:nvPr/>
        </p:nvSpPr>
        <p:spPr>
          <a:xfrm>
            <a:off x="7189017" y="3824702"/>
            <a:ext cx="329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2</a:t>
            </a:r>
            <a:endParaRPr kumimoji="1" lang="ja-JP" altLang="en-US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34AF3154-BB54-4340-AFE3-C05FBF9DC2F3}"/>
              </a:ext>
            </a:extLst>
          </p:cNvPr>
          <p:cNvSpPr txBox="1"/>
          <p:nvPr/>
        </p:nvSpPr>
        <p:spPr>
          <a:xfrm>
            <a:off x="8704415" y="3824702"/>
            <a:ext cx="320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5</a:t>
            </a:r>
            <a:endParaRPr kumimoji="1" lang="ja-JP" altLang="en-US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BE2FD2E7-41D1-43C8-897A-2713187D0712}"/>
              </a:ext>
            </a:extLst>
          </p:cNvPr>
          <p:cNvSpPr txBox="1"/>
          <p:nvPr/>
        </p:nvSpPr>
        <p:spPr>
          <a:xfrm>
            <a:off x="10205150" y="3824702"/>
            <a:ext cx="528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8</a:t>
            </a:r>
            <a:endParaRPr kumimoji="1" lang="ja-JP" altLang="en-US" dirty="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8DD3EAB4-7BFF-499A-969E-AA7C8E90FF13}"/>
              </a:ext>
            </a:extLst>
          </p:cNvPr>
          <p:cNvSpPr txBox="1"/>
          <p:nvPr/>
        </p:nvSpPr>
        <p:spPr>
          <a:xfrm>
            <a:off x="6037362" y="2406982"/>
            <a:ext cx="262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4</a:t>
            </a:r>
            <a:endParaRPr kumimoji="1" lang="ja-JP" altLang="en-US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81BD3206-12A2-4C20-81A7-D84AE8BE404E}"/>
              </a:ext>
            </a:extLst>
          </p:cNvPr>
          <p:cNvSpPr txBox="1"/>
          <p:nvPr/>
        </p:nvSpPr>
        <p:spPr>
          <a:xfrm>
            <a:off x="6037362" y="3012441"/>
            <a:ext cx="333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2</a:t>
            </a:r>
            <a:endParaRPr kumimoji="1" lang="ja-JP" altLang="en-US" dirty="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075FA70-1030-41E3-9DAE-D92EBA88BD0E}"/>
              </a:ext>
            </a:extLst>
          </p:cNvPr>
          <p:cNvSpPr txBox="1"/>
          <p:nvPr/>
        </p:nvSpPr>
        <p:spPr>
          <a:xfrm>
            <a:off x="6045314" y="1786425"/>
            <a:ext cx="275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6</a:t>
            </a:r>
            <a:endParaRPr kumimoji="1" lang="ja-JP" altLang="en-US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5869B49B-CEC4-4358-8DE0-48E349B85B9C}"/>
              </a:ext>
            </a:extLst>
          </p:cNvPr>
          <p:cNvSpPr txBox="1"/>
          <p:nvPr/>
        </p:nvSpPr>
        <p:spPr>
          <a:xfrm>
            <a:off x="6045314" y="1161292"/>
            <a:ext cx="280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8</a:t>
            </a:r>
            <a:endParaRPr kumimoji="1" lang="ja-JP" altLang="en-US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45D14AD4-C61B-4510-B397-F4D68A6E562F}"/>
              </a:ext>
            </a:extLst>
          </p:cNvPr>
          <p:cNvSpPr txBox="1"/>
          <p:nvPr/>
        </p:nvSpPr>
        <p:spPr>
          <a:xfrm>
            <a:off x="5967370" y="531245"/>
            <a:ext cx="459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10</a:t>
            </a:r>
            <a:endParaRPr kumimoji="1" lang="ja-JP" altLang="en-US" dirty="0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1B1A2654-1F0D-4BA1-A413-E3F268DFEB9A}"/>
              </a:ext>
            </a:extLst>
          </p:cNvPr>
          <p:cNvSpPr txBox="1"/>
          <p:nvPr/>
        </p:nvSpPr>
        <p:spPr>
          <a:xfrm>
            <a:off x="6049824" y="3697313"/>
            <a:ext cx="333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0</a:t>
            </a:r>
            <a:endParaRPr kumimoji="1" lang="ja-JP" altLang="en-US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DB322FCE-6D85-4CB5-8BE9-5117A5DD292E}"/>
              </a:ext>
            </a:extLst>
          </p:cNvPr>
          <p:cNvSpPr txBox="1"/>
          <p:nvPr/>
        </p:nvSpPr>
        <p:spPr>
          <a:xfrm>
            <a:off x="7715034" y="4119744"/>
            <a:ext cx="141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cs typeface="Arial" panose="020B0604020202020204" pitchFamily="34" charset="0"/>
              </a:rPr>
              <a:t>Time [</a:t>
            </a:r>
            <a:r>
              <a:rPr lang="en-US" altLang="ja-JP" dirty="0">
                <a:cs typeface="Arial" panose="020B0604020202020204" pitchFamily="34" charset="0"/>
              </a:rPr>
              <a:t>min</a:t>
            </a:r>
            <a:r>
              <a:rPr kumimoji="1" lang="en-US" altLang="ja-JP" dirty="0">
                <a:cs typeface="Arial" panose="020B0604020202020204" pitchFamily="34" charset="0"/>
              </a:rPr>
              <a:t>]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27BDAD54-A4FD-4E65-85C8-48CCA99C1FC5}"/>
              </a:ext>
            </a:extLst>
          </p:cNvPr>
          <p:cNvSpPr txBox="1"/>
          <p:nvPr/>
        </p:nvSpPr>
        <p:spPr>
          <a:xfrm>
            <a:off x="9210925" y="3824702"/>
            <a:ext cx="320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6</a:t>
            </a:r>
            <a:endParaRPr kumimoji="1" lang="ja-JP" altLang="en-US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DF5B9EB4-B55A-4DE5-B891-CB07D4A43331}"/>
              </a:ext>
            </a:extLst>
          </p:cNvPr>
          <p:cNvSpPr txBox="1"/>
          <p:nvPr/>
        </p:nvSpPr>
        <p:spPr>
          <a:xfrm>
            <a:off x="9699651" y="3824702"/>
            <a:ext cx="320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7</a:t>
            </a:r>
            <a:endParaRPr kumimoji="1" lang="ja-JP" altLang="en-US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4C833BF-FCFE-4B24-B508-452706027D15}"/>
              </a:ext>
            </a:extLst>
          </p:cNvPr>
          <p:cNvSpPr txBox="1"/>
          <p:nvPr/>
        </p:nvSpPr>
        <p:spPr>
          <a:xfrm>
            <a:off x="1277811" y="306516"/>
            <a:ext cx="3937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cs typeface="Arial" panose="020B0604020202020204" pitchFamily="34" charset="0"/>
              </a:rPr>
              <a:t>Condition (</a:t>
            </a:r>
            <a:r>
              <a:rPr lang="en-US" altLang="ja-JP" dirty="0" err="1">
                <a:cs typeface="Arial" panose="020B0604020202020204" pitchFamily="34" charset="0"/>
              </a:rPr>
              <a:t>i</a:t>
            </a:r>
            <a:r>
              <a:rPr lang="en-US" altLang="ja-JP" dirty="0">
                <a:cs typeface="Arial" panose="020B0604020202020204" pitchFamily="34" charset="0"/>
              </a:rPr>
              <a:t>) (Heat storage function)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BEAA6F7-42AA-442D-8639-AB3B8318728C}"/>
              </a:ext>
            </a:extLst>
          </p:cNvPr>
          <p:cNvSpPr txBox="1"/>
          <p:nvPr/>
        </p:nvSpPr>
        <p:spPr>
          <a:xfrm>
            <a:off x="6250265" y="306516"/>
            <a:ext cx="3954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cs typeface="Arial" panose="020B0604020202020204" pitchFamily="34" charset="0"/>
              </a:rPr>
              <a:t>Condition (ii) (No heat storage function)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5531DF60-D592-4CB1-95C9-2F324567B94D}"/>
              </a:ext>
            </a:extLst>
          </p:cNvPr>
          <p:cNvCxnSpPr/>
          <p:nvPr/>
        </p:nvCxnSpPr>
        <p:spPr>
          <a:xfrm>
            <a:off x="3573965" y="3095516"/>
            <a:ext cx="445553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C546A3DE-F2F7-4CCE-8C7C-6A302388DE1B}"/>
              </a:ext>
            </a:extLst>
          </p:cNvPr>
          <p:cNvCxnSpPr/>
          <p:nvPr/>
        </p:nvCxnSpPr>
        <p:spPr>
          <a:xfrm>
            <a:off x="3573965" y="3429000"/>
            <a:ext cx="445553" cy="0"/>
          </a:xfrm>
          <a:prstGeom prst="line">
            <a:avLst/>
          </a:prstGeom>
          <a:ln w="1905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BA35165-B38B-48B6-9D79-02EBD63550F1}"/>
              </a:ext>
            </a:extLst>
          </p:cNvPr>
          <p:cNvSpPr txBox="1"/>
          <p:nvPr/>
        </p:nvSpPr>
        <p:spPr>
          <a:xfrm>
            <a:off x="4027501" y="2910850"/>
            <a:ext cx="587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H</a:t>
            </a:r>
            <a:r>
              <a:rPr kumimoji="1" lang="en-US" altLang="ja-JP" baseline="-25000" dirty="0"/>
              <a:t>4</a:t>
            </a:r>
            <a:endParaRPr kumimoji="1" lang="ja-JP" altLang="en-US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1D1D6ED-85DD-4D45-B9CB-8E057A098E80}"/>
              </a:ext>
            </a:extLst>
          </p:cNvPr>
          <p:cNvSpPr txBox="1"/>
          <p:nvPr/>
        </p:nvSpPr>
        <p:spPr>
          <a:xfrm>
            <a:off x="4035484" y="3260789"/>
            <a:ext cx="587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O</a:t>
            </a:r>
            <a:endParaRPr kumimoji="1" lang="ja-JP" altLang="en-US" dirty="0"/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5C5D9261-7394-482F-A422-D9FC69EFA626}"/>
              </a:ext>
            </a:extLst>
          </p:cNvPr>
          <p:cNvCxnSpPr/>
          <p:nvPr/>
        </p:nvCxnSpPr>
        <p:spPr>
          <a:xfrm>
            <a:off x="9134066" y="3095516"/>
            <a:ext cx="445553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C8305988-539C-4C95-8638-2B12B21D9919}"/>
              </a:ext>
            </a:extLst>
          </p:cNvPr>
          <p:cNvCxnSpPr/>
          <p:nvPr/>
        </p:nvCxnSpPr>
        <p:spPr>
          <a:xfrm>
            <a:off x="9134066" y="3429000"/>
            <a:ext cx="445553" cy="0"/>
          </a:xfrm>
          <a:prstGeom prst="line">
            <a:avLst/>
          </a:prstGeom>
          <a:ln w="1905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F2225438-3E4D-4144-BB5B-CA7A8C29EC06}"/>
              </a:ext>
            </a:extLst>
          </p:cNvPr>
          <p:cNvSpPr txBox="1"/>
          <p:nvPr/>
        </p:nvSpPr>
        <p:spPr>
          <a:xfrm>
            <a:off x="9587602" y="2910850"/>
            <a:ext cx="587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H</a:t>
            </a:r>
            <a:r>
              <a:rPr kumimoji="1" lang="en-US" altLang="ja-JP" baseline="-25000" dirty="0"/>
              <a:t>4</a:t>
            </a:r>
            <a:endParaRPr kumimoji="1" lang="ja-JP" altLang="en-US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61B048B-16B3-402D-80FE-5552D4760BB0}"/>
              </a:ext>
            </a:extLst>
          </p:cNvPr>
          <p:cNvSpPr txBox="1"/>
          <p:nvPr/>
        </p:nvSpPr>
        <p:spPr>
          <a:xfrm>
            <a:off x="9595585" y="3260789"/>
            <a:ext cx="587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O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04196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6">
      <a:majorFont>
        <a:latin typeface="Times New Roman"/>
        <a:ea typeface="明朝"/>
        <a:cs typeface=""/>
      </a:majorFont>
      <a:minorFont>
        <a:latin typeface="Times New Roman"/>
        <a:ea typeface="明朝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52</TotalTime>
  <Words>286</Words>
  <Application>Microsoft Office PowerPoint</Application>
  <PresentationFormat>ワイド画面</PresentationFormat>
  <Paragraphs>6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mbria Math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?橋　達也</dc:creator>
  <cp:lastModifiedBy>T. Tatsuya</cp:lastModifiedBy>
  <cp:revision>150</cp:revision>
  <dcterms:created xsi:type="dcterms:W3CDTF">2019-08-21T04:15:11Z</dcterms:created>
  <dcterms:modified xsi:type="dcterms:W3CDTF">2021-03-16T13:13:15Z</dcterms:modified>
</cp:coreProperties>
</file>